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72D2C8-99F6-42D4-8F54-588B1C0EBB4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8E1989-AD7C-4443-9334-67AE83F5DD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E1B7EC-BDCB-450C-B8B0-44EAECAB33A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3F33B6-1627-47BC-AFCC-80B5598D69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3B2786-8396-4146-A485-F4ED5945DD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E29274-EDCE-4452-923C-B88F3D179C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4BFE48-73DB-4310-9856-164F4EED69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A452E1-1BEF-417D-A03C-98C6473C2D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6521C7-4B85-4EB3-8F6E-671E4ADA9A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7EFE6C-0B23-480A-8760-E004CA2B4D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E07065-64D7-46BB-9784-59F99DE167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C35829-8AFA-4C5A-8024-F10B74C754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01998A9-572A-40AE-97D7-79E1A567CDCA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3"/>
          <p:cNvSpPr/>
          <p:nvPr/>
        </p:nvSpPr>
        <p:spPr>
          <a:xfrm>
            <a:off x="5219640" y="4221000"/>
            <a:ext cx="3745080" cy="228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S1.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 Subcellular localization of BcKNOX1, BcKNOX3, BcKNOX4, BcKNOX5, BcKNOX7, and BcSTM in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Nicotiana benthamiana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. Subcellular localization assay was used to detect the localization of the six BcKNOXs. The nuclei were stained with DsRed. Bar = 50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μ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m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图片 5" descr=""/>
          <p:cNvPicPr/>
          <p:nvPr/>
        </p:nvPicPr>
        <p:blipFill>
          <a:blip r:embed="rId1"/>
          <a:stretch/>
        </p:blipFill>
        <p:spPr>
          <a:xfrm>
            <a:off x="324000" y="0"/>
            <a:ext cx="4746600" cy="685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图片 2" descr=""/>
          <p:cNvPicPr/>
          <p:nvPr/>
        </p:nvPicPr>
        <p:blipFill>
          <a:blip r:embed="rId1"/>
          <a:stretch/>
        </p:blipFill>
        <p:spPr>
          <a:xfrm>
            <a:off x="0" y="1657440"/>
            <a:ext cx="9144000" cy="3543120"/>
          </a:xfrm>
          <a:prstGeom prst="rect">
            <a:avLst/>
          </a:prstGeom>
          <a:ln w="0">
            <a:noFill/>
          </a:ln>
        </p:spPr>
      </p:pic>
      <p:sp>
        <p:nvSpPr>
          <p:cNvPr id="44" name="文本框 4"/>
          <p:cNvSpPr/>
          <p:nvPr/>
        </p:nvSpPr>
        <p:spPr>
          <a:xfrm>
            <a:off x="352440" y="5589720"/>
            <a:ext cx="85694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S2.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 Chromosomal distribution of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BcKNOX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 genes in flowering Chinese cabbage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图片 4" descr=""/>
          <p:cNvPicPr/>
          <p:nvPr/>
        </p:nvPicPr>
        <p:blipFill>
          <a:blip r:embed="rId1"/>
          <a:stretch/>
        </p:blipFill>
        <p:spPr>
          <a:xfrm>
            <a:off x="642960" y="189000"/>
            <a:ext cx="7858080" cy="5032440"/>
          </a:xfrm>
          <a:prstGeom prst="rect">
            <a:avLst/>
          </a:prstGeom>
          <a:ln w="0">
            <a:noFill/>
          </a:ln>
        </p:spPr>
      </p:pic>
      <p:sp>
        <p:nvSpPr>
          <p:cNvPr id="46" name="文本框 5"/>
          <p:cNvSpPr/>
          <p:nvPr/>
        </p:nvSpPr>
        <p:spPr>
          <a:xfrm>
            <a:off x="652320" y="5589720"/>
            <a:ext cx="80647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S3.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 Multiple sequences alignment of KNOX proteins of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Arabidopsis thaliana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 and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Brassica campestris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图片 4" descr=""/>
          <p:cNvPicPr/>
          <p:nvPr/>
        </p:nvPicPr>
        <p:blipFill>
          <a:blip r:embed="rId1"/>
          <a:stretch/>
        </p:blipFill>
        <p:spPr>
          <a:xfrm>
            <a:off x="324000" y="12600"/>
            <a:ext cx="4429080" cy="4829400"/>
          </a:xfrm>
          <a:prstGeom prst="rect">
            <a:avLst/>
          </a:prstGeom>
          <a:ln w="0">
            <a:noFill/>
          </a:ln>
        </p:spPr>
      </p:pic>
      <p:sp>
        <p:nvSpPr>
          <p:cNvPr id="48" name="文本框 5"/>
          <p:cNvSpPr/>
          <p:nvPr/>
        </p:nvSpPr>
        <p:spPr>
          <a:xfrm>
            <a:off x="216000" y="4842000"/>
            <a:ext cx="8712000" cy="2014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Figure S4.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BcKNOXs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 transcript levels of flowering Chinese cabbage stem tip in response to zeatin (ZT) and gibberellin A3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（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GA3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）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treatments. Samples were collected at three-leaf and flowering stage after exogenous hormone treatment, with water used as a control. Data represent the mean </a:t>
            </a:r>
            <a:r>
              <a:rPr b="0" lang="zh-CN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±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 standard error for three biological experiments, with standard errors shown as bar charts above the columns, while lowercase letters indicate significance at p &lt; 0.05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02T08:56:59Z</dcterms:created>
  <dc:creator>aa</dc:creator>
  <dc:description/>
  <dc:language>en-US</dc:language>
  <cp:lastModifiedBy>yanweihao</cp:lastModifiedBy>
  <dcterms:modified xsi:type="dcterms:W3CDTF">2022-10-18T03:06:30Z</dcterms:modified>
  <cp:revision>7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